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p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9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69B1D7-5903-2117-14F5-479024868196}" v="20" dt="2023-01-18T20:01:11.6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F611C-49E7-4A88-B1C8-6E6830DCEB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A1E896-12C7-4AD0-B479-C914C19F52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4963BE-D4EF-42C6-B053-90E32DCF0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C8554-CF0A-462F-9691-B47C759F1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82DE4F-C0A3-42B8-B7EE-950920FB0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392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C8218-B300-47CE-9600-026B35AE2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D733DC-73C9-44C4-85BA-DD27705A5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5FA0A-4EFC-4658-A2B2-C638DE570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061D0E-DCE1-4B3E-ACB3-E2C2E3879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EC2867-3201-4E4E-8B9F-C845B4691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788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21240D-0248-4E3D-A876-5EDC14C02A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B3892B-A003-4D58-A7F4-8581EDF29B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3BBD3-0A1A-4F48-9284-9B311C776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7121EA-8887-4A64-A5D0-47C6CBA85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0C487-CC45-4C15-B272-FA71AE205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2661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4A6AC-F105-4BE2-9B63-5B505E091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0D4C1-E1E9-4D78-B0BF-046023F95B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6FF1DB-27A8-41F1-AEEE-51177A8FB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E0D6F-522C-4FE8-81C4-813720F26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300FD-EA5A-479A-842C-D4A804F30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610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C5BCF-85BB-42D5-8B59-E45500170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17BF9D-95A9-4B77-9A06-C92F7B7E26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66669B-BF23-4E98-B85E-28FE71D7B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08A81-2C35-4A33-850B-BD4B715E4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A02EA-3AEE-44EA-807B-C470B4C13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68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496F0-7DBE-4BDD-A90D-86B7B49A15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EDA0A-72AA-4DE3-9AFC-83C8EC29D5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F5993E-7B0A-49AE-AAFA-A11585B86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D9430B-0AA2-4431-B165-005C5F680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26BA93-38EC-4FF8-AC88-5ED478DA9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408D30-1660-4515-B06E-4A83F3F01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224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2710D-2CA6-4B25-B2EC-1D5D5FEA5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91C6CD-FFF1-4DC8-824B-2F14807F1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F77700-7438-4F2B-A497-7FE1A31C5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FAE84F-4F2E-4E34-955C-ADE6FF2CB2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07C7CB-101B-4040-9091-BF8EA85006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514DAE-6AEB-4C84-AC49-65A27735D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072236-0272-4952-891E-6EECDA7D6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17BD19-94CB-4BB8-88B3-7421A15CE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2711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69ADC-ECA7-4F38-96A7-CDC32A5B6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849D90-4D51-4632-90DB-988B9A8CF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D68920-A8A2-4DF1-9B64-553EA2777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E7207E-120F-47CE-9041-1590E591A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073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779E1D-68F2-4E7E-B563-F91FBE9BC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BA0F0C-41FC-4B85-9531-546D3750E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42ACE1-D9E8-438B-AE72-24ED950BB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5053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050404-DB2E-41A4-8B39-28D06671B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E197D-BC09-4C75-AD89-1F51700073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4295F-7C89-4967-BD65-143477FE2B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B92D21-9FAC-4224-9456-F0B01F652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B097AC-35F0-4D94-A67F-DAF8F399F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F63373-84ED-46D6-AA6E-DCBCD680D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42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5C208-C3C6-4634-AC58-76844300D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DB919-D76F-46F6-90EF-9C7E021C02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03050A-BA01-41B7-8D24-2EB481B82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A3554D-CCAE-42D1-B2D6-B9B308E1A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684912-2B27-4B94-82A7-CF05307E2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8955E-4ED3-42DC-8E74-C64A94E72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563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CDE195-090C-4558-A448-FF038471E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081386-DA41-4913-A492-C473E6D77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5EC69E-E870-4DA4-9945-4E370158F4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89A1F-22C6-45F3-A1C0-A255AD4F3795}" type="datetimeFigureOut">
              <a:rPr lang="en-GB" smtClean="0"/>
              <a:t>18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CD819-04A4-423E-A89F-594691E538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ABCD7-790B-4FC8-8564-8A9428B44B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60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EE92C4E-D533-4C02-89EE-2D0DD3562F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22453"/>
            <a:ext cx="6984647" cy="4328843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7AB0D519-3C65-4761-8B4F-2A9964DE7D46}"/>
              </a:ext>
            </a:extLst>
          </p:cNvPr>
          <p:cNvGrpSpPr/>
          <p:nvPr/>
        </p:nvGrpSpPr>
        <p:grpSpPr>
          <a:xfrm>
            <a:off x="693243" y="5829342"/>
            <a:ext cx="5598160" cy="538480"/>
            <a:chOff x="3289300" y="5087620"/>
            <a:chExt cx="5598160" cy="53848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EAEA963-3759-4668-AB0B-6B9C77DB5E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7" t="48163" r="48906" b="47604"/>
            <a:stretch/>
          </p:blipFill>
          <p:spPr>
            <a:xfrm>
              <a:off x="3289300" y="5087620"/>
              <a:ext cx="5142230" cy="26924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79EB867-C3F0-422E-AF7B-523A7AD0CA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82" t="48163" r="8458" b="47604"/>
            <a:stretch/>
          </p:blipFill>
          <p:spPr>
            <a:xfrm>
              <a:off x="3978910" y="5356860"/>
              <a:ext cx="4908550" cy="269240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1B231A4E-5736-4E24-97B4-1091EC3FC2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6532" y="109992"/>
            <a:ext cx="3645531" cy="22593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FC7F1C2-ED8A-4A9C-8110-5232CD80520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6530" y="2323714"/>
            <a:ext cx="3645531" cy="225937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7810DF5-26B2-4677-93D3-84BAC5A3A46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6531" y="4598625"/>
            <a:ext cx="3645531" cy="225937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BC686B9-C267-46F3-B2A1-3923CAA15A87}"/>
              </a:ext>
            </a:extLst>
          </p:cNvPr>
          <p:cNvSpPr txBox="1"/>
          <p:nvPr/>
        </p:nvSpPr>
        <p:spPr>
          <a:xfrm>
            <a:off x="126262" y="51169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64E268-FE4D-4A51-8B9D-458B012F030B}"/>
              </a:ext>
            </a:extLst>
          </p:cNvPr>
          <p:cNvSpPr txBox="1"/>
          <p:nvPr/>
        </p:nvSpPr>
        <p:spPr>
          <a:xfrm>
            <a:off x="7750810" y="17619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8F9D9A7-F064-4D4E-8468-6791CCFEA619}"/>
              </a:ext>
            </a:extLst>
          </p:cNvPr>
          <p:cNvSpPr txBox="1"/>
          <p:nvPr/>
        </p:nvSpPr>
        <p:spPr>
          <a:xfrm>
            <a:off x="7750810" y="39756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A5D23D-B07F-49F3-B18C-4AC7FD226909}"/>
              </a:ext>
            </a:extLst>
          </p:cNvPr>
          <p:cNvSpPr txBox="1"/>
          <p:nvPr/>
        </p:nvSpPr>
        <p:spPr>
          <a:xfrm>
            <a:off x="7750810" y="61831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BBA654-DDF6-4F32-851E-B1F3F0376271}"/>
              </a:ext>
            </a:extLst>
          </p:cNvPr>
          <p:cNvSpPr txBox="1"/>
          <p:nvPr/>
        </p:nvSpPr>
        <p:spPr>
          <a:xfrm>
            <a:off x="126262" y="177121"/>
            <a:ext cx="7220659" cy="7078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latin typeface="Arial"/>
                <a:cs typeface="Arial"/>
              </a:rPr>
              <a:t>Figure S1</a:t>
            </a:r>
            <a:r>
              <a:rPr lang="en-GB" sz="2000" dirty="0">
                <a:latin typeface="Arial"/>
                <a:cs typeface="Arial"/>
              </a:rPr>
              <a:t> DAH in polio priority-transition countries in the past 18 years by type of channel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72C2FD-6F23-4C3E-A505-FBAB768E0006}"/>
              </a:ext>
            </a:extLst>
          </p:cNvPr>
          <p:cNvSpPr txBox="1"/>
          <p:nvPr/>
        </p:nvSpPr>
        <p:spPr>
          <a:xfrm>
            <a:off x="126262" y="814182"/>
            <a:ext cx="77329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ll polio transition priority countries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 and those based on their WHO regions: AF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, EM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, and SEA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7494236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C75E3AC-F6D0-46D5-8BE2-6347328834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144" y="0"/>
            <a:ext cx="9508992" cy="6858000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5A93A0ED-F99E-4874-A9D3-AF0A6154CB29}"/>
              </a:ext>
            </a:extLst>
          </p:cNvPr>
          <p:cNvGrpSpPr/>
          <p:nvPr/>
        </p:nvGrpSpPr>
        <p:grpSpPr>
          <a:xfrm>
            <a:off x="6481696" y="6138164"/>
            <a:ext cx="5598160" cy="538480"/>
            <a:chOff x="3289300" y="5087620"/>
            <a:chExt cx="5598160" cy="53848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B0B176E-C810-41F9-92EA-39BB860300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7" t="48163" r="48906" b="47604"/>
            <a:stretch/>
          </p:blipFill>
          <p:spPr>
            <a:xfrm>
              <a:off x="3289300" y="5087620"/>
              <a:ext cx="5142230" cy="26924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55BAADD-0FE8-4821-A87C-425BE35CDA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82" t="48163" r="8458" b="47604"/>
            <a:stretch/>
          </p:blipFill>
          <p:spPr>
            <a:xfrm>
              <a:off x="3978910" y="5356860"/>
              <a:ext cx="4908550" cy="269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51740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481E498-4732-4712-8873-CDA15FD54C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144" y="0"/>
            <a:ext cx="9508992" cy="68580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969ECF00-53AE-4045-A349-09DC337C6275}"/>
              </a:ext>
            </a:extLst>
          </p:cNvPr>
          <p:cNvGrpSpPr/>
          <p:nvPr/>
        </p:nvGrpSpPr>
        <p:grpSpPr>
          <a:xfrm>
            <a:off x="6481696" y="6138164"/>
            <a:ext cx="5598160" cy="538480"/>
            <a:chOff x="3289300" y="5087620"/>
            <a:chExt cx="5598160" cy="53848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09D39B5-BC08-413B-9234-893CBDB365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7" t="48163" r="48906" b="47604"/>
            <a:stretch/>
          </p:blipFill>
          <p:spPr>
            <a:xfrm>
              <a:off x="3289300" y="5087620"/>
              <a:ext cx="5142230" cy="26924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34DB626-907F-4B93-A1D0-5DB51CD5A4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82" t="48163" r="8458" b="47604"/>
            <a:stretch/>
          </p:blipFill>
          <p:spPr>
            <a:xfrm>
              <a:off x="3978910" y="5356860"/>
              <a:ext cx="4908550" cy="269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52805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847E198-EC20-4B5D-9B33-1D56298FB5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60" y="0"/>
            <a:ext cx="9508992" cy="68580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9CB882AC-7A14-494C-8ED2-AF9FA90BD8D8}"/>
              </a:ext>
            </a:extLst>
          </p:cNvPr>
          <p:cNvGrpSpPr/>
          <p:nvPr/>
        </p:nvGrpSpPr>
        <p:grpSpPr>
          <a:xfrm>
            <a:off x="6481696" y="6138164"/>
            <a:ext cx="5598160" cy="538480"/>
            <a:chOff x="3289300" y="5087620"/>
            <a:chExt cx="5598160" cy="53848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8B370D5-4B4F-4AFC-BF84-572F55B017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7" t="48163" r="48906" b="47604"/>
            <a:stretch/>
          </p:blipFill>
          <p:spPr>
            <a:xfrm>
              <a:off x="3289300" y="5087620"/>
              <a:ext cx="5142230" cy="26924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E593B93-DD67-4FBC-A2B8-E57E0322CF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82" t="48163" r="8458" b="47604"/>
            <a:stretch/>
          </p:blipFill>
          <p:spPr>
            <a:xfrm>
              <a:off x="3978910" y="5356860"/>
              <a:ext cx="4908550" cy="2692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03943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1bac29d-635b-4ff2-84e9-4347505f3004" xsi:nil="true"/>
    <lcf76f155ced4ddcb4097134ff3c332f xmlns="76b97e0f-0b6c-4862-a8b7-8ef0847a5b25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B671BC794A474F93336529414137EE" ma:contentTypeVersion="15" ma:contentTypeDescription="Creare un nuovo documento." ma:contentTypeScope="" ma:versionID="b03df75e6add1e186a17ac61d52fe19f">
  <xsd:schema xmlns:xsd="http://www.w3.org/2001/XMLSchema" xmlns:xs="http://www.w3.org/2001/XMLSchema" xmlns:p="http://schemas.microsoft.com/office/2006/metadata/properties" xmlns:ns2="76b97e0f-0b6c-4862-a8b7-8ef0847a5b25" xmlns:ns3="31bac29d-635b-4ff2-84e9-4347505f3004" targetNamespace="http://schemas.microsoft.com/office/2006/metadata/properties" ma:root="true" ma:fieldsID="e11bfff66511e86a94f6a0fabd31907d" ns2:_="" ns3:_="">
    <xsd:import namespace="76b97e0f-0b6c-4862-a8b7-8ef0847a5b25"/>
    <xsd:import namespace="31bac29d-635b-4ff2-84e9-4347505f300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Location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b97e0f-0b6c-4862-a8b7-8ef0847a5b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Tag immagine" ma:readOnly="false" ma:fieldId="{5cf76f15-5ced-4ddc-b409-7134ff3c332f}" ma:taxonomyMulti="true" ma:sspId="aa4eac88-8ae6-4a96-90c7-97bc93c844e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bac29d-635b-4ff2-84e9-4347505f3004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cad81af6-b875-4386-8c2f-e831e19173c4}" ma:internalName="TaxCatchAll" ma:showField="CatchAllData" ma:web="31bac29d-635b-4ff2-84e9-4347505f300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D3FCBD9-FD8C-4309-B677-4A35AF709AD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D996186-1CFD-4E97-A849-EA3B18BA3E3E}">
  <ds:schemaRefs>
    <ds:schemaRef ds:uri="4dd27b94-49dd-407e-a06f-ee9bee375f57"/>
    <ds:schemaRef ds:uri="http://purl.org/dc/dcmitype/"/>
    <ds:schemaRef ds:uri="http://purl.org/dc/terms/"/>
    <ds:schemaRef ds:uri="http://schemas.openxmlformats.org/package/2006/metadata/core-properties"/>
    <ds:schemaRef ds:uri="http://www.w3.org/XML/1998/namespace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68436cf0-bded-48b0-966e-c872f964e37c"/>
    <ds:schemaRef ds:uri="http://schemas.microsoft.com/office/2006/metadata/properties"/>
    <ds:schemaRef ds:uri="31bac29d-635b-4ff2-84e9-4347505f3004"/>
    <ds:schemaRef ds:uri="76b97e0f-0b6c-4862-a8b7-8ef0847a5b25"/>
  </ds:schemaRefs>
</ds:datastoreItem>
</file>

<file path=customXml/itemProps3.xml><?xml version="1.0" encoding="utf-8"?>
<ds:datastoreItem xmlns:ds="http://schemas.openxmlformats.org/officeDocument/2006/customXml" ds:itemID="{1DDCAE84-B2E9-4366-AE7A-E1C03348F8FF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Villa</dc:creator>
  <cp:lastModifiedBy>Simone Villa</cp:lastModifiedBy>
  <cp:revision>16</cp:revision>
  <dcterms:created xsi:type="dcterms:W3CDTF">2022-12-27T20:42:42Z</dcterms:created>
  <dcterms:modified xsi:type="dcterms:W3CDTF">2023-01-18T20:02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B671BC794A474F93336529414137EE</vt:lpwstr>
  </property>
  <property fmtid="{D5CDD505-2E9C-101B-9397-08002B2CF9AE}" pid="3" name="MediaServiceImageTags">
    <vt:lpwstr/>
  </property>
</Properties>
</file>